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8.wmf" ContentType="image/x-wmf"/>
  <Override PartName="/ppt/media/image13.png" ContentType="image/png"/>
  <Override PartName="/ppt/media/image7.wmf" ContentType="image/x-wmf"/>
  <Override PartName="/ppt/media/image12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10.png" ContentType="image/png"/>
  <Override PartName="/ppt/media/image5.wmf" ContentType="image/x-wmf"/>
  <Override PartName="/ppt/media/image11.png" ContentType="image/png"/>
  <Override PartName="/ppt/media/image6.wmf" ContentType="image/x-wmf"/>
  <Override PartName="/ppt/embeddings/oleObject1.xlsx" ContentType="application/vnd.openxmlformats-officedocument.spreadsheetml.sheet"/>
  <Override PartName="/ppt/embeddings/oleObject4.bin" ContentType="application/vnd.openxmlformats-officedocument.oleObject"/>
  <Override PartName="/ppt/embeddings/oleObject2.xlsx" ContentType="application/vnd.openxmlformats-officedocument.spreadsheetml.sheet"/>
  <Override PartName="/ppt/embeddings/oleObject2.bin" ContentType="application/vnd.openxmlformats-officedocument.oleObject"/>
  <Override PartName="/ppt/embeddings/oleObject1.bin" ContentType="application/vnd.openxmlformats-officedocument.oleObject"/>
  <Override PartName="/ppt/embeddings/oleObject3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9F67AA-EC6F-40A5-8DF6-0D4ADB066A9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820515-9B6D-4F05-AED0-B42EEEAE191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FF848E-159E-4BED-A811-92ECAC88403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7B9169-FA80-4A28-A4DC-C4E2D6085E4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1BA03F-3009-4827-9B5A-A4714BCDDD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DE5BEA-BD68-4E18-AEFD-F84911D6F4A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89A971-BFC0-49FA-8A6C-1D473E7AF94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38B0BF-6D49-4282-82E9-1B405BDA804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506135-29C4-40BA-B9AF-D0CFFCDD042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CA9088-FCE2-4EBE-A21B-DA0510B09E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7E9EAC-42C6-4CD0-86E8-81CFC394CC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2A9CFB-ED39-4C67-8825-371D043321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D1363BC-214D-42FC-94A9-57C1575E8CF0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image" Target="../media/image3.wmf"/><Relationship Id="rId3" Type="http://schemas.openxmlformats.org/officeDocument/2006/relationships/image" Target="../media/image4.wmf"/><Relationship Id="rId4" Type="http://schemas.openxmlformats.org/officeDocument/2006/relationships/package" Target="../embeddings/oleObject1.xlsx"/><Relationship Id="rId5" Type="http://schemas.openxmlformats.org/officeDocument/2006/relationships/image" Target="../media/image5.wmf"/><Relationship Id="rId6" Type="http://schemas.openxmlformats.org/officeDocument/2006/relationships/package" Target="../embeddings/oleObject2.xlsx"/><Relationship Id="rId7" Type="http://schemas.openxmlformats.org/officeDocument/2006/relationships/image" Target="../media/image6.wmf"/><Relationship Id="rId8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7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8.wmf"/><Relationship Id="rId5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9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10.png"/><Relationship Id="rId5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1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13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14.png"/><Relationship Id="rId9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image" Target="../media/image16.png"/><Relationship Id="rId3" Type="http://schemas.openxmlformats.org/officeDocument/2006/relationships/image" Target="../media/image17.png"/><Relationship Id="rId4" Type="http://schemas.openxmlformats.org/officeDocument/2006/relationships/image" Target="../media/image18.png"/><Relationship Id="rId5" Type="http://schemas.openxmlformats.org/officeDocument/2006/relationships/slideLayout" Target="../slideLayouts/slideLayout3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601080" y="8304120"/>
            <a:ext cx="3024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Kuhlmann et al. Suppl. Figure 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1069920" y="3106800"/>
            <a:ext cx="4716360" cy="2933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"/>
          <p:cNvSpPr/>
          <p:nvPr/>
        </p:nvSpPr>
        <p:spPr>
          <a:xfrm>
            <a:off x="3601080" y="8304120"/>
            <a:ext cx="3024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Kuhlmann et al. Suppl. Figure 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792440" y="2962440"/>
            <a:ext cx="3181320" cy="90360"/>
          </a:xfrm>
          <a:custGeom>
            <a:avLst/>
            <a:gdLst/>
            <a:ahLst/>
            <a:rect l="l" t="t" r="r" b="b"/>
            <a:pathLst>
              <a:path w="548" h="17">
                <a:moveTo>
                  <a:pt x="9" y="0"/>
                </a:moveTo>
                <a:lnTo>
                  <a:pt x="539" y="0"/>
                </a:lnTo>
                <a:cubicBezTo>
                  <a:pt x="544" y="0"/>
                  <a:pt x="548" y="4"/>
                  <a:pt x="548" y="8"/>
                </a:cubicBezTo>
                <a:lnTo>
                  <a:pt x="548" y="8"/>
                </a:lnTo>
                <a:cubicBezTo>
                  <a:pt x="548" y="13"/>
                  <a:pt x="544" y="17"/>
                  <a:pt x="539" y="17"/>
                </a:cubicBezTo>
                <a:lnTo>
                  <a:pt x="9" y="17"/>
                </a:lnTo>
                <a:cubicBezTo>
                  <a:pt x="4" y="17"/>
                  <a:pt x="0" y="13"/>
                  <a:pt x="0" y="8"/>
                </a:cubicBezTo>
                <a:lnTo>
                  <a:pt x="0" y="8"/>
                </a:lnTo>
                <a:cubicBezTo>
                  <a:pt x="0" y="4"/>
                  <a:pt x="4" y="0"/>
                  <a:pt x="9" y="0"/>
                </a:cubicBezTo>
                <a:close/>
              </a:path>
            </a:pathLst>
          </a:custGeom>
          <a:noFill/>
          <a:ln w="0">
            <a:solidFill>
              <a:srgbClr val="24211d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4178160" y="2962440"/>
            <a:ext cx="725760" cy="90360"/>
          </a:xfrm>
          <a:prstGeom prst="rect">
            <a:avLst/>
          </a:prstGeom>
          <a:solidFill>
            <a:srgbClr val="eb3d00"/>
          </a:solidFill>
          <a:ln w="0">
            <a:solidFill>
              <a:srgbClr val="24211d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489040" y="2962440"/>
            <a:ext cx="1101960" cy="90360"/>
          </a:xfrm>
          <a:prstGeom prst="rect">
            <a:avLst/>
          </a:prstGeom>
          <a:solidFill>
            <a:srgbClr val="fdfa00"/>
          </a:solidFill>
          <a:ln w="0">
            <a:solidFill>
              <a:srgbClr val="24211d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685960" y="3087720"/>
            <a:ext cx="6530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24211d"/>
                </a:solidFill>
                <a:latin typeface="Tahoma"/>
              </a:rPr>
              <a:t>SRA-doma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4248720" y="3087720"/>
            <a:ext cx="6361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24211d"/>
                </a:solidFill>
                <a:latin typeface="Tahoma"/>
              </a:rPr>
              <a:t>SET-doma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4875120" y="2828880"/>
            <a:ext cx="28800" cy="842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4886280" y="2725560"/>
            <a:ext cx="127080" cy="113040"/>
          </a:xfrm>
          <a:custGeom>
            <a:avLst/>
            <a:gdLst/>
            <a:ahLst/>
            <a:rect l="l" t="t" r="r" b="b"/>
            <a:pathLst>
              <a:path w="22" h="21">
                <a:moveTo>
                  <a:pt x="0" y="19"/>
                </a:moveTo>
                <a:lnTo>
                  <a:pt x="20" y="0"/>
                </a:lnTo>
                <a:lnTo>
                  <a:pt x="22" y="2"/>
                </a:lnTo>
                <a:lnTo>
                  <a:pt x="2" y="21"/>
                </a:lnTo>
                <a:lnTo>
                  <a:pt x="0" y="19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4764240" y="2725560"/>
            <a:ext cx="122040" cy="113040"/>
          </a:xfrm>
          <a:custGeom>
            <a:avLst/>
            <a:gdLst/>
            <a:ahLst/>
            <a:rect l="l" t="t" r="r" b="b"/>
            <a:pathLst>
              <a:path w="21" h="21">
                <a:moveTo>
                  <a:pt x="20" y="21"/>
                </a:moveTo>
                <a:lnTo>
                  <a:pt x="0" y="2"/>
                </a:lnTo>
                <a:lnTo>
                  <a:pt x="2" y="0"/>
                </a:lnTo>
                <a:lnTo>
                  <a:pt x="21" y="19"/>
                </a:lnTo>
                <a:lnTo>
                  <a:pt x="20" y="21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2413080" y="2828880"/>
            <a:ext cx="23760" cy="842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424240" y="2725560"/>
            <a:ext cx="122040" cy="113040"/>
          </a:xfrm>
          <a:custGeom>
            <a:avLst/>
            <a:gdLst/>
            <a:ahLst/>
            <a:rect l="l" t="t" r="r" b="b"/>
            <a:pathLst>
              <a:path w="21" h="21">
                <a:moveTo>
                  <a:pt x="0" y="19"/>
                </a:moveTo>
                <a:lnTo>
                  <a:pt x="19" y="0"/>
                </a:lnTo>
                <a:lnTo>
                  <a:pt x="21" y="2"/>
                </a:lnTo>
                <a:lnTo>
                  <a:pt x="1" y="21"/>
                </a:lnTo>
                <a:lnTo>
                  <a:pt x="0" y="19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297160" y="2725560"/>
            <a:ext cx="127080" cy="113040"/>
          </a:xfrm>
          <a:custGeom>
            <a:avLst/>
            <a:gdLst/>
            <a:ahLst/>
            <a:rect l="l" t="t" r="r" b="b"/>
            <a:pathLst>
              <a:path w="22" h="21">
                <a:moveTo>
                  <a:pt x="20" y="21"/>
                </a:moveTo>
                <a:lnTo>
                  <a:pt x="0" y="2"/>
                </a:lnTo>
                <a:lnTo>
                  <a:pt x="2" y="0"/>
                </a:lnTo>
                <a:lnTo>
                  <a:pt x="22" y="19"/>
                </a:lnTo>
                <a:lnTo>
                  <a:pt x="20" y="21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4238280" y="2584440"/>
            <a:ext cx="910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24211d"/>
                </a:solidFill>
                <a:latin typeface="Tahoma"/>
              </a:rPr>
              <a:t>Gabi-Kat_516A0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241000" y="2577960"/>
            <a:ext cx="7095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24211d"/>
                </a:solidFill>
                <a:latin typeface="Tahoma"/>
              </a:rPr>
              <a:t>SALK_07957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936160" y="3209760"/>
            <a:ext cx="1073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ahoma"/>
              </a:rPr>
              <a:t>At2g33290 SUVH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792440" y="4875120"/>
            <a:ext cx="3181320" cy="90720"/>
          </a:xfrm>
          <a:custGeom>
            <a:avLst/>
            <a:gdLst/>
            <a:ahLst/>
            <a:rect l="l" t="t" r="r" b="b"/>
            <a:pathLst>
              <a:path w="548" h="17">
                <a:moveTo>
                  <a:pt x="9" y="0"/>
                </a:moveTo>
                <a:lnTo>
                  <a:pt x="539" y="0"/>
                </a:lnTo>
                <a:cubicBezTo>
                  <a:pt x="544" y="0"/>
                  <a:pt x="548" y="4"/>
                  <a:pt x="548" y="9"/>
                </a:cubicBezTo>
                <a:lnTo>
                  <a:pt x="548" y="9"/>
                </a:lnTo>
                <a:cubicBezTo>
                  <a:pt x="548" y="13"/>
                  <a:pt x="544" y="17"/>
                  <a:pt x="539" y="17"/>
                </a:cubicBezTo>
                <a:lnTo>
                  <a:pt x="9" y="17"/>
                </a:lnTo>
                <a:cubicBezTo>
                  <a:pt x="4" y="17"/>
                  <a:pt x="0" y="13"/>
                  <a:pt x="0" y="9"/>
                </a:cubicBezTo>
                <a:lnTo>
                  <a:pt x="0" y="9"/>
                </a:lnTo>
                <a:cubicBezTo>
                  <a:pt x="0" y="4"/>
                  <a:pt x="4" y="0"/>
                  <a:pt x="9" y="0"/>
                </a:cubicBezTo>
                <a:close/>
              </a:path>
            </a:pathLst>
          </a:custGeom>
          <a:noFill/>
          <a:ln w="0">
            <a:solidFill>
              <a:srgbClr val="24211d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4178160" y="4875120"/>
            <a:ext cx="725760" cy="90720"/>
          </a:xfrm>
          <a:prstGeom prst="rect">
            <a:avLst/>
          </a:prstGeom>
          <a:solidFill>
            <a:srgbClr val="eb3d00"/>
          </a:solidFill>
          <a:ln w="0">
            <a:solidFill>
              <a:srgbClr val="24211d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2489040" y="4875120"/>
            <a:ext cx="1101960" cy="90720"/>
          </a:xfrm>
          <a:prstGeom prst="rect">
            <a:avLst/>
          </a:prstGeom>
          <a:solidFill>
            <a:srgbClr val="fdfa00"/>
          </a:solidFill>
          <a:ln w="0">
            <a:solidFill>
              <a:srgbClr val="24211d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2685960" y="5000760"/>
            <a:ext cx="6530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24211d"/>
                </a:solidFill>
                <a:latin typeface="Tahoma"/>
              </a:rPr>
              <a:t>SRA-doma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4248720" y="5000760"/>
            <a:ext cx="6361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24211d"/>
                </a:solidFill>
                <a:latin typeface="Tahoma"/>
              </a:rPr>
              <a:t>SET-doma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2936160" y="5124600"/>
            <a:ext cx="1073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ahoma"/>
              </a:rPr>
              <a:t>At4g13460 SUVH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2610000" y="4738680"/>
            <a:ext cx="29880" cy="9036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2622600" y="4641840"/>
            <a:ext cx="120600" cy="108000"/>
          </a:xfrm>
          <a:custGeom>
            <a:avLst/>
            <a:gdLst/>
            <a:ahLst/>
            <a:rect l="l" t="t" r="r" b="b"/>
            <a:pathLst>
              <a:path w="21" h="20">
                <a:moveTo>
                  <a:pt x="0" y="18"/>
                </a:moveTo>
                <a:lnTo>
                  <a:pt x="20" y="0"/>
                </a:lnTo>
                <a:lnTo>
                  <a:pt x="21" y="1"/>
                </a:lnTo>
                <a:lnTo>
                  <a:pt x="2" y="20"/>
                </a:lnTo>
                <a:lnTo>
                  <a:pt x="0" y="18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2500200" y="4641840"/>
            <a:ext cx="122400" cy="108000"/>
          </a:xfrm>
          <a:custGeom>
            <a:avLst/>
            <a:gdLst/>
            <a:ahLst/>
            <a:rect l="l" t="t" r="r" b="b"/>
            <a:pathLst>
              <a:path w="21" h="20">
                <a:moveTo>
                  <a:pt x="20" y="20"/>
                </a:moveTo>
                <a:lnTo>
                  <a:pt x="0" y="1"/>
                </a:lnTo>
                <a:lnTo>
                  <a:pt x="2" y="0"/>
                </a:lnTo>
                <a:lnTo>
                  <a:pt x="21" y="18"/>
                </a:lnTo>
                <a:lnTo>
                  <a:pt x="20" y="2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2442600" y="4491000"/>
            <a:ext cx="7095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24211d"/>
                </a:solidFill>
                <a:latin typeface="Tahoma"/>
              </a:rPr>
              <a:t>SALK_04803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2557440" y="5016600"/>
            <a:ext cx="30240" cy="8712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2448000" y="5092560"/>
            <a:ext cx="127080" cy="112680"/>
          </a:xfrm>
          <a:custGeom>
            <a:avLst/>
            <a:gdLst/>
            <a:ahLst/>
            <a:rect l="l" t="t" r="r" b="b"/>
            <a:pathLst>
              <a:path w="22" h="21">
                <a:moveTo>
                  <a:pt x="22" y="2"/>
                </a:moveTo>
                <a:lnTo>
                  <a:pt x="2" y="21"/>
                </a:lnTo>
                <a:lnTo>
                  <a:pt x="0" y="19"/>
                </a:lnTo>
                <a:lnTo>
                  <a:pt x="20" y="0"/>
                </a:lnTo>
                <a:lnTo>
                  <a:pt x="22" y="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2575080" y="5092560"/>
            <a:ext cx="122040" cy="112680"/>
          </a:xfrm>
          <a:custGeom>
            <a:avLst/>
            <a:gdLst/>
            <a:ahLst/>
            <a:rect l="l" t="t" r="r" b="b"/>
            <a:pathLst>
              <a:path w="21" h="21">
                <a:moveTo>
                  <a:pt x="1" y="0"/>
                </a:moveTo>
                <a:lnTo>
                  <a:pt x="21" y="19"/>
                </a:lnTo>
                <a:lnTo>
                  <a:pt x="19" y="21"/>
                </a:lnTo>
                <a:lnTo>
                  <a:pt x="0" y="2"/>
                </a:lnTo>
                <a:lnTo>
                  <a:pt x="1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2202840" y="5210280"/>
            <a:ext cx="7095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24211d"/>
                </a:solidFill>
                <a:latin typeface="Tahoma"/>
              </a:rPr>
              <a:t>SALK_04809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2171880" y="3643200"/>
            <a:ext cx="2392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LB-p1::SUL1-p35S&gt; RB RB &lt;p35S-SUL1::P1-L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1464840" y="3476520"/>
            <a:ext cx="910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24211d"/>
                </a:solidFill>
                <a:latin typeface="Tahoma"/>
              </a:rPr>
              <a:t>Gabi-Kat_516A0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2241720" y="3838680"/>
            <a:ext cx="1150920" cy="68040"/>
          </a:xfrm>
          <a:prstGeom prst="rightArrow">
            <a:avLst>
              <a:gd name="adj1" fmla="val 50000"/>
              <a:gd name="adj2" fmla="val 422884"/>
            </a:avLst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2600" bIns="-12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 rot="10800000">
            <a:off x="3357360" y="3838320"/>
            <a:ext cx="1150920" cy="68040"/>
          </a:xfrm>
          <a:prstGeom prst="rightArrow">
            <a:avLst>
              <a:gd name="adj1" fmla="val 50000"/>
              <a:gd name="adj2" fmla="val 422884"/>
            </a:avLst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2600" bIns="-12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4508640" y="3808440"/>
            <a:ext cx="433080" cy="13320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1808280" y="3808440"/>
            <a:ext cx="433440" cy="13320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1415880" y="4040280"/>
            <a:ext cx="1269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TGAACGGCAA 1937b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4041000" y="4040280"/>
            <a:ext cx="1256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946bp CTGCAACTA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2423880" y="3906720"/>
            <a:ext cx="547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AC16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 rot="10800000">
            <a:off x="3741480" y="3889800"/>
            <a:ext cx="547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AC16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"/>
          <p:cNvSpPr/>
          <p:nvPr/>
        </p:nvSpPr>
        <p:spPr>
          <a:xfrm>
            <a:off x="3601080" y="8304120"/>
            <a:ext cx="3024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Kuhlmann et al. Suppl. Figure 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3" name=""/>
          <p:cNvGrpSpPr/>
          <p:nvPr/>
        </p:nvGrpSpPr>
        <p:grpSpPr>
          <a:xfrm>
            <a:off x="33120" y="1949400"/>
            <a:ext cx="6791400" cy="5251320"/>
            <a:chOff x="33120" y="1949400"/>
            <a:chExt cx="6791400" cy="5251320"/>
          </a:xfrm>
        </p:grpSpPr>
        <p:pic>
          <p:nvPicPr>
            <p:cNvPr id="84" name="" descr=""/>
            <p:cNvPicPr/>
            <p:nvPr/>
          </p:nvPicPr>
          <p:blipFill>
            <a:blip r:embed="rId1"/>
            <a:stretch/>
          </p:blipFill>
          <p:spPr>
            <a:xfrm>
              <a:off x="339840" y="1949400"/>
              <a:ext cx="2666880" cy="1819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5" name="" descr=""/>
            <p:cNvPicPr/>
            <p:nvPr/>
          </p:nvPicPr>
          <p:blipFill>
            <a:blip r:embed="rId2"/>
            <a:stretch/>
          </p:blipFill>
          <p:spPr>
            <a:xfrm>
              <a:off x="285840" y="3744360"/>
              <a:ext cx="2736720" cy="1808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6" name="" descr=""/>
            <p:cNvPicPr/>
            <p:nvPr/>
          </p:nvPicPr>
          <p:blipFill>
            <a:blip r:embed="rId3"/>
            <a:stretch/>
          </p:blipFill>
          <p:spPr>
            <a:xfrm>
              <a:off x="450720" y="5556960"/>
              <a:ext cx="2552760" cy="1643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7" name=""/>
            <p:cNvSpPr/>
            <p:nvPr/>
          </p:nvSpPr>
          <p:spPr>
            <a:xfrm>
              <a:off x="909360" y="1969920"/>
              <a:ext cx="173412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SUVH2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/ 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PFK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rel. 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838080" y="3823560"/>
              <a:ext cx="173412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SUVH9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/ 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PFK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rel. 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956160" y="5605200"/>
              <a:ext cx="161532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ACT2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/ 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PFK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rel. 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819720" y="6953400"/>
              <a:ext cx="218628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wt       </a:t>
              </a:r>
              <a:r>
                <a:rPr b="0" i="1" lang="de-DE" sz="1000" spc="-1" strike="noStrike">
                  <a:solidFill>
                    <a:srgbClr val="000000"/>
                  </a:solidFill>
                  <a:latin typeface="Arial"/>
                </a:rPr>
                <a:t>suvh2      suvh9 suvh2 suvh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819720" y="3571560"/>
              <a:ext cx="218628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wt       </a:t>
              </a:r>
              <a:r>
                <a:rPr b="0" i="1" lang="de-DE" sz="1000" spc="-1" strike="noStrike">
                  <a:solidFill>
                    <a:srgbClr val="000000"/>
                  </a:solidFill>
                  <a:latin typeface="Arial"/>
                </a:rPr>
                <a:t>suvh2      suvh9 suvh2 suvh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819720" y="5339880"/>
              <a:ext cx="218628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wt       </a:t>
              </a:r>
              <a:r>
                <a:rPr b="0" i="1" lang="de-DE" sz="1000" spc="-1" strike="noStrike">
                  <a:solidFill>
                    <a:srgbClr val="000000"/>
                  </a:solidFill>
                  <a:latin typeface="Arial"/>
                </a:rPr>
                <a:t>suvh2      suvh9 suvh2 suvh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33120" y="1950480"/>
              <a:ext cx="282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33120" y="3745800"/>
              <a:ext cx="282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33120" y="553932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96" name=""/>
            <p:cNvGraphicFramePr/>
            <p:nvPr/>
          </p:nvGraphicFramePr>
          <p:xfrm>
            <a:off x="3157560" y="2334600"/>
            <a:ext cx="3666960" cy="2189160"/>
          </p:xfrm>
          <a:graphic>
            <a:graphicData uri="http://schemas.openxmlformats.org/presentationml/2006/ole">
              <p:oleObj progId="Excel.Sheet.12" r:id="rId4" spid="">
                <p:embed/>
                <p:pic>
                  <p:nvPicPr>
                    <p:cNvPr id="97" name="" descr=""/>
                    <p:cNvPicPr/>
                    <p:nvPr/>
                  </p:nvPicPr>
                  <p:blipFill>
                    <a:blip r:embed="rId5"/>
                    <a:stretch/>
                  </p:blipFill>
                  <p:spPr>
                    <a:xfrm>
                      <a:off x="3157560" y="2334600"/>
                      <a:ext cx="3666960" cy="21891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98" name=""/>
            <p:cNvGraphicFramePr/>
            <p:nvPr/>
          </p:nvGraphicFramePr>
          <p:xfrm>
            <a:off x="3192480" y="4592520"/>
            <a:ext cx="3311640" cy="1976760"/>
          </p:xfrm>
          <a:graphic>
            <a:graphicData uri="http://schemas.openxmlformats.org/presentationml/2006/ole">
              <p:oleObj progId="Excel.Sheet.12" r:id="rId6" spid="">
                <p:embed/>
                <p:pic>
                  <p:nvPicPr>
                    <p:cNvPr id="99" name="" descr=""/>
                    <p:cNvPicPr/>
                    <p:nvPr/>
                  </p:nvPicPr>
                  <p:blipFill>
                    <a:blip r:embed="rId7"/>
                    <a:stretch/>
                  </p:blipFill>
                  <p:spPr>
                    <a:xfrm>
                      <a:off x="3192480" y="4592520"/>
                      <a:ext cx="3311640" cy="19767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00" name=""/>
            <p:cNvSpPr/>
            <p:nvPr/>
          </p:nvSpPr>
          <p:spPr>
            <a:xfrm>
              <a:off x="2936520" y="238896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2944440" y="4925160"/>
              <a:ext cx="282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3898800" y="4301280"/>
              <a:ext cx="267696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wt             </a:t>
              </a:r>
              <a:r>
                <a:rPr b="0" i="1" lang="de-DE" sz="1000" spc="-1" strike="noStrike">
                  <a:solidFill>
                    <a:srgbClr val="000000"/>
                  </a:solidFill>
                  <a:latin typeface="Arial"/>
                </a:rPr>
                <a:t>suvh2           suvh9    suvh2 suvh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3848040" y="6387840"/>
              <a:ext cx="267696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wt             </a:t>
              </a:r>
              <a:r>
                <a:rPr b="0" i="1" lang="de-DE" sz="1000" spc="-1" strike="noStrike">
                  <a:solidFill>
                    <a:srgbClr val="000000"/>
                  </a:solidFill>
                  <a:latin typeface="Arial"/>
                </a:rPr>
                <a:t>suvh2           suvh9    suvh2 suvh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"/>
          <p:cNvSpPr/>
          <p:nvPr/>
        </p:nvSpPr>
        <p:spPr>
          <a:xfrm>
            <a:off x="3601080" y="8304120"/>
            <a:ext cx="3024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Kuhlmann et al. Suppl. Figure 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5" name=""/>
          <p:cNvGrpSpPr/>
          <p:nvPr/>
        </p:nvGrpSpPr>
        <p:grpSpPr>
          <a:xfrm>
            <a:off x="1034640" y="1449360"/>
            <a:ext cx="3862800" cy="3056040"/>
            <a:chOff x="1034640" y="1449360"/>
            <a:chExt cx="3862800" cy="3056040"/>
          </a:xfrm>
        </p:grpSpPr>
        <p:graphicFrame>
          <p:nvGraphicFramePr>
            <p:cNvPr id="106" name=""/>
            <p:cNvGraphicFramePr/>
            <p:nvPr/>
          </p:nvGraphicFramePr>
          <p:xfrm>
            <a:off x="1960560" y="1449360"/>
            <a:ext cx="2936880" cy="305604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107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1960560" y="1449360"/>
                      <a:ext cx="2936880" cy="30560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08" name=""/>
            <p:cNvSpPr/>
            <p:nvPr/>
          </p:nvSpPr>
          <p:spPr>
            <a:xfrm rot="16200000">
              <a:off x="1233000" y="2698200"/>
              <a:ext cx="114084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% methyla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2591280" y="3740040"/>
              <a:ext cx="2188080" cy="398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de-DE" sz="1000" spc="-1" strike="noStrike">
                  <a:solidFill>
                    <a:srgbClr val="000000"/>
                  </a:solidFill>
                  <a:latin typeface="Arial"/>
                </a:rPr>
                <a:t>     </a:t>
              </a:r>
              <a:r>
                <a:rPr b="0" i="1" lang="de-DE" sz="10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               </a:t>
              </a:r>
              <a:r>
                <a:rPr b="0" i="1" lang="de-DE" sz="1000" spc="-1" strike="noStrike">
                  <a:solidFill>
                    <a:srgbClr val="000000"/>
                  </a:solidFill>
                  <a:latin typeface="Arial"/>
                </a:rPr>
                <a:t>Pro35S-mycSUVH2</a:t>
              </a: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   </a:t>
              </a: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leaves                      leav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1034640" y="1700280"/>
              <a:ext cx="282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1990080" y="1714680"/>
              <a:ext cx="372600" cy="23511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2" name=""/>
          <p:cNvGrpSpPr/>
          <p:nvPr/>
        </p:nvGrpSpPr>
        <p:grpSpPr>
          <a:xfrm>
            <a:off x="1017360" y="4338720"/>
            <a:ext cx="4788000" cy="2662200"/>
            <a:chOff x="1017360" y="4338720"/>
            <a:chExt cx="4788000" cy="2662200"/>
          </a:xfrm>
        </p:grpSpPr>
        <p:graphicFrame>
          <p:nvGraphicFramePr>
            <p:cNvPr id="113" name=""/>
            <p:cNvGraphicFramePr/>
            <p:nvPr/>
          </p:nvGraphicFramePr>
          <p:xfrm>
            <a:off x="1484280" y="4338720"/>
            <a:ext cx="4321080" cy="2662200"/>
          </p:xfrm>
          <a:graphic>
            <a:graphicData uri="http://schemas.openxmlformats.org/presentationml/2006/ole">
              <p:oleObj progId="Excel.Sheet.12" r:id="rId3" spid="">
                <p:embed/>
                <p:pic>
                  <p:nvPicPr>
                    <p:cNvPr id="114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1484280" y="4338720"/>
                      <a:ext cx="4321080" cy="26622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15" name=""/>
            <p:cNvSpPr/>
            <p:nvPr/>
          </p:nvSpPr>
          <p:spPr>
            <a:xfrm rot="16200000">
              <a:off x="764640" y="5436720"/>
              <a:ext cx="114084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% methyla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1951200" y="6573960"/>
              <a:ext cx="3744360" cy="398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de-DE" sz="1000" spc="-1" strike="noStrike">
                  <a:solidFill>
                    <a:srgbClr val="000000"/>
                  </a:solidFill>
                  <a:latin typeface="Arial"/>
                </a:rPr>
                <a:t>          </a:t>
              </a:r>
              <a:r>
                <a:rPr b="0" i="1" lang="de-DE" sz="10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                                </a:t>
              </a:r>
              <a:r>
                <a:rPr b="0" i="1" lang="de-DE" sz="10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                   </a:t>
              </a:r>
              <a:r>
                <a:rPr b="0" i="1" lang="de-DE" sz="1000" spc="-1" strike="noStrike">
                  <a:solidFill>
                    <a:srgbClr val="000000"/>
                  </a:solidFill>
                  <a:latin typeface="Arial"/>
                </a:rPr>
                <a:t>Pro35S-mycSUVH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       </a:t>
              </a: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leaves                        seedlings                         leav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1017360" y="4551480"/>
              <a:ext cx="282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1434600" y="4519440"/>
              <a:ext cx="372600" cy="23511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7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3200400" y="4675320"/>
              <a:ext cx="303120" cy="1126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3591000" y="4675320"/>
              <a:ext cx="119160" cy="1126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3787920" y="4675320"/>
              <a:ext cx="160200" cy="1126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4029120" y="4675320"/>
              <a:ext cx="191880" cy="1126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3112920" y="4649760"/>
              <a:ext cx="129564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total C            CG     CHG      CH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"/>
          <p:cNvSpPr/>
          <p:nvPr/>
        </p:nvSpPr>
        <p:spPr>
          <a:xfrm>
            <a:off x="3601080" y="8304120"/>
            <a:ext cx="3024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Kuhlmann et al. Suppl. Figure 6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5" name=""/>
          <p:cNvGrpSpPr/>
          <p:nvPr/>
        </p:nvGrpSpPr>
        <p:grpSpPr>
          <a:xfrm>
            <a:off x="1867680" y="3220920"/>
            <a:ext cx="3121920" cy="2639880"/>
            <a:chOff x="1867680" y="3220920"/>
            <a:chExt cx="3121920" cy="2639880"/>
          </a:xfrm>
        </p:grpSpPr>
        <p:graphicFrame>
          <p:nvGraphicFramePr>
            <p:cNvPr id="126" name=""/>
            <p:cNvGraphicFramePr/>
            <p:nvPr/>
          </p:nvGraphicFramePr>
          <p:xfrm>
            <a:off x="2574720" y="4478760"/>
            <a:ext cx="1428480" cy="138204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127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2574720" y="4478760"/>
                      <a:ext cx="1428480" cy="13820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28" name=""/>
            <p:cNvSpPr/>
            <p:nvPr/>
          </p:nvSpPr>
          <p:spPr>
            <a:xfrm>
              <a:off x="1867680" y="5407920"/>
              <a:ext cx="749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4mer -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 rot="17034600">
              <a:off x="2631240" y="4095360"/>
              <a:ext cx="358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3390840" y="4003920"/>
              <a:ext cx="183600" cy="281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 rot="17184600">
              <a:off x="2972520" y="3702960"/>
              <a:ext cx="1235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suvh2  suvh9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 rot="17034600">
              <a:off x="2909160" y="4090680"/>
              <a:ext cx="358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 rot="17184600">
              <a:off x="3305880" y="3704040"/>
              <a:ext cx="1235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suvh2  suvh9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4078800" y="5472360"/>
              <a:ext cx="910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tSN1 (A)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4063320" y="4750200"/>
              <a:ext cx="545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t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aphicFrame>
        <p:nvGraphicFramePr>
          <p:cNvPr id="136" name=""/>
          <p:cNvGraphicFramePr/>
          <p:nvPr/>
        </p:nvGraphicFramePr>
        <p:xfrm>
          <a:off x="2565360" y="5867280"/>
          <a:ext cx="1440000" cy="50796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37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565360" y="5867280"/>
                    <a:ext cx="1440000" cy="507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38" name=""/>
          <p:cNvSpPr/>
          <p:nvPr/>
        </p:nvSpPr>
        <p:spPr>
          <a:xfrm>
            <a:off x="4059000" y="6012000"/>
            <a:ext cx="47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EtB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"/>
          <p:cNvSpPr/>
          <p:nvPr/>
        </p:nvSpPr>
        <p:spPr>
          <a:xfrm>
            <a:off x="3601080" y="8304120"/>
            <a:ext cx="3024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Kuhlmann et al. Suppl. Figure 7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0" name=""/>
          <p:cNvGrpSpPr/>
          <p:nvPr/>
        </p:nvGrpSpPr>
        <p:grpSpPr>
          <a:xfrm>
            <a:off x="117000" y="2967120"/>
            <a:ext cx="6624720" cy="3214080"/>
            <a:chOff x="117000" y="2967120"/>
            <a:chExt cx="6624720" cy="3214080"/>
          </a:xfrm>
        </p:grpSpPr>
        <p:graphicFrame>
          <p:nvGraphicFramePr>
            <p:cNvPr id="141" name=""/>
            <p:cNvGraphicFramePr/>
            <p:nvPr/>
          </p:nvGraphicFramePr>
          <p:xfrm>
            <a:off x="710280" y="4727160"/>
            <a:ext cx="2534040" cy="132336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142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710280" y="4727160"/>
                      <a:ext cx="2534040" cy="13233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143" name=""/>
            <p:cNvGraphicFramePr/>
            <p:nvPr/>
          </p:nvGraphicFramePr>
          <p:xfrm>
            <a:off x="3574080" y="4857840"/>
            <a:ext cx="3018240" cy="132336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144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3574080" y="4857840"/>
                      <a:ext cx="3018240" cy="13233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145" name=""/>
            <p:cNvGraphicFramePr/>
            <p:nvPr/>
          </p:nvGraphicFramePr>
          <p:xfrm>
            <a:off x="3799440" y="3112920"/>
            <a:ext cx="2942280" cy="1324440"/>
          </p:xfrm>
          <a:graphic>
            <a:graphicData uri="http://schemas.openxmlformats.org/presentationml/2006/ole">
              <p:oleObj r:id="rId5" spid="">
                <p:embed/>
                <p:pic>
                  <p:nvPicPr>
                    <p:cNvPr id="146" name="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3799440" y="3112920"/>
                      <a:ext cx="2942280" cy="13244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147" name=""/>
            <p:cNvGraphicFramePr/>
            <p:nvPr/>
          </p:nvGraphicFramePr>
          <p:xfrm>
            <a:off x="594720" y="3243960"/>
            <a:ext cx="2426400" cy="1324440"/>
          </p:xfrm>
          <a:graphic>
            <a:graphicData uri="http://schemas.openxmlformats.org/presentationml/2006/ole">
              <p:oleObj r:id="rId7" spid="">
                <p:embed/>
                <p:pic>
                  <p:nvPicPr>
                    <p:cNvPr id="148" name="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594720" y="3243960"/>
                      <a:ext cx="2426400" cy="13244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49" name=""/>
            <p:cNvSpPr/>
            <p:nvPr/>
          </p:nvSpPr>
          <p:spPr>
            <a:xfrm>
              <a:off x="117000" y="2967120"/>
              <a:ext cx="282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3562920" y="3011040"/>
              <a:ext cx="282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117360" y="471168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3531600" y="469548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53" name=""/>
          <p:cNvGrpSpPr/>
          <p:nvPr/>
        </p:nvGrpSpPr>
        <p:grpSpPr>
          <a:xfrm>
            <a:off x="717480" y="5877000"/>
            <a:ext cx="2463840" cy="179280"/>
            <a:chOff x="717480" y="5877000"/>
            <a:chExt cx="2463840" cy="179280"/>
          </a:xfrm>
        </p:grpSpPr>
        <p:sp>
          <p:nvSpPr>
            <p:cNvPr id="154" name=""/>
            <p:cNvSpPr/>
            <p:nvPr/>
          </p:nvSpPr>
          <p:spPr>
            <a:xfrm>
              <a:off x="717480" y="5877000"/>
              <a:ext cx="2463840" cy="171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790560" y="5937120"/>
              <a:ext cx="71280" cy="7164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810360" y="5886360"/>
              <a:ext cx="36504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total C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1155600" y="5937120"/>
              <a:ext cx="71640" cy="71640"/>
            </a:xfrm>
            <a:prstGeom prst="rect">
              <a:avLst/>
            </a:prstGeom>
            <a:solidFill>
              <a:srgbClr val="80808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1172520" y="5886360"/>
              <a:ext cx="27684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C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1514520" y="5937120"/>
              <a:ext cx="71280" cy="71640"/>
            </a:xfrm>
            <a:prstGeom prst="rect">
              <a:avLst/>
            </a:prstGeom>
            <a:solidFill>
              <a:srgbClr val="c0c0c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1533240" y="5886360"/>
              <a:ext cx="3225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CH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1874880" y="5937120"/>
              <a:ext cx="71280" cy="71640"/>
            </a:xfrm>
            <a:prstGeom prst="rect">
              <a:avLst/>
            </a:prstGeom>
            <a:solidFill>
              <a:srgbClr val="ff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1896120" y="5886360"/>
              <a:ext cx="3178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CH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" name="" descr=""/>
          <p:cNvPicPr/>
          <p:nvPr/>
        </p:nvPicPr>
        <p:blipFill>
          <a:blip r:embed="rId1"/>
          <a:stretch/>
        </p:blipFill>
        <p:spPr>
          <a:xfrm>
            <a:off x="1890720" y="119160"/>
            <a:ext cx="3591000" cy="2104920"/>
          </a:xfrm>
          <a:prstGeom prst="rect">
            <a:avLst/>
          </a:prstGeom>
          <a:ln w="0">
            <a:noFill/>
          </a:ln>
        </p:spPr>
      </p:pic>
      <p:sp>
        <p:nvSpPr>
          <p:cNvPr id="164" name=""/>
          <p:cNvSpPr/>
          <p:nvPr/>
        </p:nvSpPr>
        <p:spPr>
          <a:xfrm>
            <a:off x="47160" y="179280"/>
            <a:ext cx="1486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CR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SUVH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5" name="" descr=""/>
          <p:cNvPicPr/>
          <p:nvPr/>
        </p:nvPicPr>
        <p:blipFill>
          <a:blip r:embed="rId2"/>
          <a:stretch/>
        </p:blipFill>
        <p:spPr>
          <a:xfrm>
            <a:off x="1701720" y="2511360"/>
            <a:ext cx="3672000" cy="2152800"/>
          </a:xfrm>
          <a:prstGeom prst="rect">
            <a:avLst/>
          </a:prstGeom>
          <a:ln w="0">
            <a:noFill/>
          </a:ln>
        </p:spPr>
      </p:pic>
      <p:sp>
        <p:nvSpPr>
          <p:cNvPr id="166" name=""/>
          <p:cNvSpPr/>
          <p:nvPr/>
        </p:nvSpPr>
        <p:spPr>
          <a:xfrm>
            <a:off x="2520" y="2544840"/>
            <a:ext cx="1486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CR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SUVH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7" name="" descr=""/>
          <p:cNvPicPr/>
          <p:nvPr/>
        </p:nvPicPr>
        <p:blipFill>
          <a:blip r:embed="rId3"/>
          <a:stretch/>
        </p:blipFill>
        <p:spPr>
          <a:xfrm>
            <a:off x="1846440" y="4605480"/>
            <a:ext cx="3375000" cy="1979640"/>
          </a:xfrm>
          <a:prstGeom prst="rect">
            <a:avLst/>
          </a:prstGeom>
          <a:ln w="0">
            <a:noFill/>
          </a:ln>
        </p:spPr>
      </p:pic>
      <p:sp>
        <p:nvSpPr>
          <p:cNvPr id="168" name=""/>
          <p:cNvSpPr/>
          <p:nvPr/>
        </p:nvSpPr>
        <p:spPr>
          <a:xfrm>
            <a:off x="46080" y="4665600"/>
            <a:ext cx="1171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CR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PF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9" name="" descr=""/>
          <p:cNvPicPr/>
          <p:nvPr/>
        </p:nvPicPr>
        <p:blipFill>
          <a:blip r:embed="rId4"/>
          <a:stretch/>
        </p:blipFill>
        <p:spPr>
          <a:xfrm>
            <a:off x="1701720" y="6794640"/>
            <a:ext cx="3429000" cy="2011320"/>
          </a:xfrm>
          <a:prstGeom prst="rect">
            <a:avLst/>
          </a:prstGeom>
          <a:ln w="0">
            <a:noFill/>
          </a:ln>
        </p:spPr>
      </p:pic>
      <p:sp>
        <p:nvSpPr>
          <p:cNvPr id="170" name=""/>
          <p:cNvSpPr/>
          <p:nvPr/>
        </p:nvSpPr>
        <p:spPr>
          <a:xfrm>
            <a:off x="46440" y="6826320"/>
            <a:ext cx="1310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CR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ACT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3750120" y="8715240"/>
            <a:ext cx="3024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Kuhlmann et al. Suppl. Figure 8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2" name="PlaceHolder 1"/>
          <p:cNvSpPr>
            <a:spLocks noGrp="1"/>
          </p:cNvSpPr>
          <p:nvPr>
            <p:ph type="title"/>
          </p:nvPr>
        </p:nvSpPr>
        <p:spPr>
          <a:xfrm>
            <a:off x="2970360" y="-141480"/>
            <a:ext cx="3914640" cy="896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Suppl. Table: Sequences of used prim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PlaceHolder 2"/>
          <p:cNvSpPr>
            <a:spLocks noGrp="1"/>
          </p:cNvSpPr>
          <p:nvPr>
            <p:ph/>
          </p:nvPr>
        </p:nvSpPr>
        <p:spPr>
          <a:xfrm>
            <a:off x="342720" y="179280"/>
            <a:ext cx="6172200" cy="6034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66000"/>
          </a:bodyPr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rimers used for genotyping: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suvh2: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UVH2-gaby-F: ATATGCAGGTGTAGTTGTCACGA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UVH2-gaby-R: ATGGCGAGCTTGCCGTTCACTT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T-DNA-insertion pAC161: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AC161 5´-out: ATATTGACCATCATACTCATTG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AC161-F (NOS): GATGTCCGCAGCGTTATTATAAAAT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AC161-R (NOS): CGCATAATCTCAGACCAATCTG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suvh9: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UVH9-SALK-F: ATGGGTTCTTCTCACATTCCTCTT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UVH9-SALK-R: CAGTGATCCTCACTAGCTCCGAC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T-DNA-insertion pROK2: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ROK2 3´-out: GAAATATTTGCTAGCTGATAGT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ROK2-F (pNOS): GAGCGGAGAATTAAGGGA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ROK2-R (pNOS): GAGAACCTGCGTGCAAT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rimers used for qPCR: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At4g04040 (Phospfofructokinase, Kapoor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et al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., 2005):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 (B8F): gccacgaaaaccaaacagac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	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 (B8R): ccggaatttcgatcaatcct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At3g18780 (Actin-2 An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et al.,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1996):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: tgagagattcagatgcccagaa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	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: ttgattccagcagcttcc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At2g33290 (SUVH2):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: atatgcaggtgtagttgtcacgag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	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: atggcgagcttgccgttcactt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At4g13460 (SUVH9):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: atgggttcttctcacattcctctt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	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: cagtgatcctcactagctccgac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AtSN1-A (AtSN1- Fragment A):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 (F4) aaaataagtggtggttgtacaagc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	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 (ATS15): accaacgtgctgttggcccagtggtaaat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AtSN1-B (AtSN1- Fragment B):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 (A205): tgagagatttaccactgggccaaca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	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 (A206): tgaggagctcaacacataaatggcaat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AtSN1-C (AtSN1- Fragment C):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 (A207): cctttccaagacaccatctcaacaac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	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 (A208): tcctcaacaaaaataattccgaacga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rimers used for converted target regions: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AtSN1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(chromosome III, nucleotides 15,805,617–15,805,773) :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AtSN1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-bi-F: caatatacratccaaaaaacarttattaaaataatatcttaa (JP 1821, Johnson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et al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., 2008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AtSN1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-bi-R: gttgtataagtttagttttaattttayggatyagtattaattt (JP 1822, Johnson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et al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., 2008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AtCopia4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: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AtCopia4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-bi-F: ggttgtytgtgttttttatggttyagattttata (JP 3100, Johnson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et al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., 2008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AtCopia4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-bi-R:  ataactraaccacarattcaracccattttcattt (JP 3101, Johnson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et al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., 2008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rimers used for quantitative amplification of genomic regions after ChIP: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At4g04040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(Phospfofructokinase, beta-subunit, Mathieu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et al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., 2003):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: gccacgaaaaccaaacagac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	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: ccggaatttcgatcaatcct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At3g18780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(Actin-2 An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et al.,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1996):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: tgagagattcagatgcccagaa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	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: ttgattccagcagcttcc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800" spc="-1" strike="noStrike">
                <a:solidFill>
                  <a:srgbClr val="000000"/>
                </a:solidFill>
                <a:latin typeface="Arial"/>
              </a:rPr>
              <a:t>Ta3-LTR</a:t>
            </a:r>
            <a:r>
              <a:rPr b="0" lang="fr-FR" sz="800" spc="-1" strike="noStrike">
                <a:solidFill>
                  <a:srgbClr val="000000"/>
                </a:solidFill>
                <a:latin typeface="Arial"/>
              </a:rPr>
              <a:t> (Johnson </a:t>
            </a:r>
            <a:r>
              <a:rPr b="0" i="1" lang="fr-FR" sz="800" spc="-1" strike="noStrike">
                <a:solidFill>
                  <a:srgbClr val="000000"/>
                </a:solidFill>
                <a:latin typeface="Arial"/>
              </a:rPr>
              <a:t>et al.,</a:t>
            </a:r>
            <a:r>
              <a:rPr b="0" lang="fr-FR" sz="800" spc="-1" strike="noStrike">
                <a:solidFill>
                  <a:srgbClr val="000000"/>
                </a:solidFill>
                <a:latin typeface="Arial"/>
              </a:rPr>
              <a:t> 2002):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</a:rPr>
              <a:t>F (JP1617): tagggttcttagttgatcttgtattgagctc</a:t>
            </a:r>
            <a:r>
              <a:rPr b="0" lang="fr-FR" sz="800" spc="-1" strike="noStrike">
                <a:solidFill>
                  <a:srgbClr val="000000"/>
                </a:solidFill>
                <a:latin typeface="Arial"/>
              </a:rPr>
              <a:t>	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</a:rPr>
              <a:t>R  (JP1618): tttgctctcaaactctcaattgaagtt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800" spc="-1" strike="noStrike">
                <a:solidFill>
                  <a:srgbClr val="000000"/>
                </a:solidFill>
                <a:latin typeface="Arial"/>
              </a:rPr>
              <a:t>AtSN1</a:t>
            </a:r>
            <a:r>
              <a:rPr b="0" lang="fr-FR" sz="800" spc="-1" strike="noStrike">
                <a:solidFill>
                  <a:srgbClr val="000000"/>
                </a:solidFill>
                <a:latin typeface="Arial"/>
              </a:rPr>
              <a:t>-A (AtSN1- Fragment A, Herr </a:t>
            </a:r>
            <a:r>
              <a:rPr b="0" i="1" lang="fr-FR" sz="800" spc="-1" strike="noStrike">
                <a:solidFill>
                  <a:srgbClr val="000000"/>
                </a:solidFill>
                <a:latin typeface="Arial"/>
              </a:rPr>
              <a:t>et al</a:t>
            </a:r>
            <a:r>
              <a:rPr b="0" lang="fr-FR" sz="800" spc="-1" strike="noStrike">
                <a:solidFill>
                  <a:srgbClr val="000000"/>
                </a:solidFill>
                <a:latin typeface="Arial"/>
              </a:rPr>
              <a:t>., 2005):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</a:rPr>
              <a:t>F (F4) aaaataagtggtggttgtacaagc</a:t>
            </a:r>
            <a:r>
              <a:rPr b="0" lang="fr-FR" sz="800" spc="-1" strike="noStrike">
                <a:solidFill>
                  <a:srgbClr val="000000"/>
                </a:solidFill>
                <a:latin typeface="Arial"/>
              </a:rPr>
              <a:t>	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</a:rPr>
              <a:t>R (ATS15): accaacgtgctgttggcccagtggtaaat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800" spc="-1" strike="noStrike">
                <a:solidFill>
                  <a:srgbClr val="000000"/>
                </a:solidFill>
                <a:latin typeface="Arial"/>
              </a:rPr>
              <a:t>AtSN1</a:t>
            </a:r>
            <a:r>
              <a:rPr b="0" lang="fr-FR" sz="800" spc="-1" strike="noStrike">
                <a:solidFill>
                  <a:srgbClr val="000000"/>
                </a:solidFill>
                <a:latin typeface="Arial"/>
              </a:rPr>
              <a:t>-B (AtSN1- Fragment B):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</a:rPr>
              <a:t>F (A205): tgagagatttaccactgggccaaca</a:t>
            </a:r>
            <a:r>
              <a:rPr b="0" lang="fr-FR" sz="800" spc="-1" strike="noStrike">
                <a:solidFill>
                  <a:srgbClr val="000000"/>
                </a:solidFill>
                <a:latin typeface="Arial"/>
              </a:rPr>
              <a:t>	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</a:rPr>
              <a:t>R (A206): tgaggagctcaacacataaatggcaat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800" spc="-1" strike="noStrike">
                <a:solidFill>
                  <a:srgbClr val="000000"/>
                </a:solidFill>
                <a:latin typeface="Arial"/>
              </a:rPr>
              <a:t>AtSN1</a:t>
            </a:r>
            <a:r>
              <a:rPr b="0" lang="fr-FR" sz="800" spc="-1" strike="noStrike">
                <a:solidFill>
                  <a:srgbClr val="000000"/>
                </a:solidFill>
                <a:latin typeface="Arial"/>
              </a:rPr>
              <a:t>-C (AtSN1- Fragment C):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</a:rPr>
              <a:t>F (A207): cctttccaagacaccatctcaacaac</a:t>
            </a:r>
            <a:r>
              <a:rPr b="0" lang="fr-FR" sz="800" spc="-1" strike="noStrike">
                <a:solidFill>
                  <a:srgbClr val="000000"/>
                </a:solidFill>
                <a:latin typeface="Arial"/>
              </a:rPr>
              <a:t>	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marL="226080" indent="0">
              <a:lnSpc>
                <a:spcPct val="90000"/>
              </a:lnSpc>
              <a:spcBef>
                <a:spcPts val="2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</a:rPr>
              <a:t>R (A208): tcctcaacaaaaataattccgaacga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3600000" y="8304120"/>
            <a:ext cx="2788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Kuhlmann et al. Suppl. Tabl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0-17T12:24:22Z</dcterms:created>
  <dc:creator>eg-21</dc:creator>
  <dc:description/>
  <dc:language>en-US</dc:language>
  <cp:lastModifiedBy>eg-21</cp:lastModifiedBy>
  <dcterms:modified xsi:type="dcterms:W3CDTF">2012-05-02T12:02:08Z</dcterms:modified>
  <cp:revision>4</cp:revision>
  <dc:subject/>
  <dc:title>Folie 1</dc:title>
</cp:coreProperties>
</file>